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8" r:id="rId2"/>
    <p:sldId id="269" r:id="rId3"/>
    <p:sldId id="256" r:id="rId4"/>
    <p:sldId id="270" r:id="rId5"/>
    <p:sldId id="271" r:id="rId6"/>
    <p:sldId id="272" r:id="rId7"/>
    <p:sldId id="273" r:id="rId8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2"/>
    <p:restoredTop sz="95909"/>
  </p:normalViewPr>
  <p:slideViewPr>
    <p:cSldViewPr snapToGrid="0" snapToObjects="1">
      <p:cViewPr varScale="1">
        <p:scale>
          <a:sx n="103" d="100"/>
          <a:sy n="103" d="100"/>
        </p:scale>
        <p:origin x="200" y="4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871867-9775-4F4F-90C9-BE98B5B77E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8E87DF-693F-EB41-B9CC-519758AAAD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3B23AA-0D30-694F-85E7-C5D1479A80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845FB6-1F3B-504C-AF3D-C27AA9858C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D77719C-9D5F-FF4D-96C3-E48F33A5F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358672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BF6DC4-49EC-DF46-A020-9BA2D8E7C1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E1ABC8F-9C8E-874A-8718-DE178F85DF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F319B6-0417-9346-99BF-DFA525873F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F79377-22CF-3246-83F0-62373BD3EE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2891AB-21BE-CE44-865B-1988F2E703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75185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CA8542-6A66-864B-81B6-F7D1FC755C6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8E0756-A7FB-7242-8EE4-0332A54893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02D652A-D383-9145-8103-C47C880D27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EA15AE-E53B-D040-BF71-8172558E47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F47664-A8F5-4C48-B379-9256851FD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34979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31F6C6-9264-EA45-887F-B635F967B8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9EFF92-36DF-E84E-9A56-9E73147558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132F82-9452-FD4F-940E-D4EA2B079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AF2702-801A-7C4F-9C45-DC3F2B8C6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DE62FF-8506-104B-91B7-D89563F16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506842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B2C78C-3E5C-EE4E-A57E-AFC3FE4FB7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799252-7345-C841-B8BB-B1E8172DC7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064429-2E43-5A4D-948B-627B84F20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9F2FA1-2C3C-DF40-808E-558517B9EA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5173D6-CCA6-3B49-851A-67F5510923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46805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302F71-BD95-794B-A0A7-3F3EB1973F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C07BC5-73C6-BC40-ACFB-8F6DE3D0F4A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37A2A1-E707-AB42-BC4C-BF79EAE019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7A6B95-5AE9-CE47-8B6A-3CD224BFE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B57766-BF22-1B4C-A41E-81E7FC51F9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A2C864-B6F4-684E-95FE-C3A5EAE695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61519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0777A2-5011-BF45-808D-A9AE82A1AE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C019371-E909-A34C-80A8-6DFA9ECD39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C9375E-7A3A-1743-A6F4-996B5CE3B7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6D2D38A-5635-6F45-85A5-72DDFBD870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78A6C8C-027E-3D4B-BB30-B61E00386BA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558AD32-5C13-B04A-80FB-27ED77699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0C5726-9B67-734B-9D80-7E49C8BE82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E65433-5E02-F54D-A2A9-83BF889BF2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572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2CADC8-B364-1F44-AFD5-2A5EB2728D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C12CC68-DE9C-C64A-82C2-090B7E2F4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0D74064-353D-6242-B803-379A7171C0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0A86D7-54E5-8D48-9C64-8E9187F885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7448145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40070B-8837-934A-BDAD-C5BD9EC807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49B8CDC-8D02-604A-9834-E86209839A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958AD89-DCD9-BC40-B714-D5FACEF7DF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34065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C1E1F3-42F1-9249-9EA9-21F22ACC78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55A13B-5950-6F46-9608-77D6E7FE6B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9BD2CA-7D4F-BC4D-8950-7D6C79FC3D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27EA3A-88EA-5643-9D9D-2757B519C2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2B35C1-4CC3-FC41-A046-8AFC214B7C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9B3DCB9-6A33-744D-B41F-009251DAD0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73323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A7E656-8F0B-824D-9A46-216AB10D4E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2580BFF-C98C-8F47-B4D0-B5C10A6568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99D5C0-0C1D-C047-AD05-73700D2DD0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41AD3B-AA61-304A-A709-D5D25979D2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081DAB-FCE7-404D-8BED-31C33802A5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B3B054-9C9A-314D-8CCD-ECF4ACC25C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40548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BE6C4EB-ADD7-9C47-95B6-A52E646AF7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0E945A-AD78-3F49-9F3B-44A657683B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FAB2F86-B111-B249-B015-5871B68D021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35C48A-2E7B-B64C-8942-4EC14EA692D6}" type="datetimeFigureOut">
              <a:rPr lang="sv-SE" smtClean="0"/>
              <a:t>2023-03-14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8C417E-8B34-684E-A2C5-091E2BAFB9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9F7CAD-41DD-794A-8114-D9949961C9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78FA81-4FE5-AD41-BD9A-34F4DE7E9D2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26439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613C2B9-67B4-AF98-C372-8887DB05767A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3</a:t>
            </a:r>
          </a:p>
        </p:txBody>
      </p:sp>
      <p:pic>
        <p:nvPicPr>
          <p:cNvPr id="6" name="Picture 5" descr="A picture containing text&#10;&#10;Description automatically generated">
            <a:extLst>
              <a:ext uri="{FF2B5EF4-FFF2-40B4-BE49-F238E27FC236}">
                <a16:creationId xmlns:a16="http://schemas.microsoft.com/office/drawing/2014/main" id="{B05B019F-A8E0-1AB7-960C-6F6B4A219E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6681" t="4279" r="7549" b="8254"/>
          <a:stretch/>
        </p:blipFill>
        <p:spPr>
          <a:xfrm>
            <a:off x="1785256" y="587046"/>
            <a:ext cx="5889173" cy="4789714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3EC29CD-D117-8F19-2FB0-917A218B89B1}"/>
              </a:ext>
            </a:extLst>
          </p:cNvPr>
          <p:cNvSpPr txBox="1"/>
          <p:nvPr/>
        </p:nvSpPr>
        <p:spPr>
          <a:xfrm>
            <a:off x="1060818" y="3244334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MTIF3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BC69A34B-8F7F-3190-7060-3A24600E7F20}"/>
              </a:ext>
            </a:extLst>
          </p:cNvPr>
          <p:cNvCxnSpPr>
            <a:cxnSpLocks/>
          </p:cNvCxnSpPr>
          <p:nvPr/>
        </p:nvCxnSpPr>
        <p:spPr>
          <a:xfrm>
            <a:off x="1835389" y="3437824"/>
            <a:ext cx="436756" cy="26595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AD0EA181-8E8C-2B07-F05F-248DD8D43392}"/>
              </a:ext>
            </a:extLst>
          </p:cNvPr>
          <p:cNvCxnSpPr/>
          <p:nvPr/>
        </p:nvCxnSpPr>
        <p:spPr>
          <a:xfrm>
            <a:off x="1673938" y="3918086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96A6181C-2FAF-3917-6EA9-FF3D61E988F3}"/>
              </a:ext>
            </a:extLst>
          </p:cNvPr>
          <p:cNvSpPr txBox="1"/>
          <p:nvPr/>
        </p:nvSpPr>
        <p:spPr>
          <a:xfrm>
            <a:off x="899732" y="373342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25 kDa</a:t>
            </a:r>
          </a:p>
        </p:txBody>
      </p:sp>
    </p:spTree>
    <p:extLst>
      <p:ext uri="{BB962C8B-B14F-4D97-AF65-F5344CB8AC3E}">
        <p14:creationId xmlns:p14="http://schemas.microsoft.com/office/powerpoint/2010/main" val="3967407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CBD8759-14DC-3122-C8A3-EC84676D2817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3</a:t>
            </a:r>
          </a:p>
        </p:txBody>
      </p:sp>
      <p:pic>
        <p:nvPicPr>
          <p:cNvPr id="6" name="Picture 5" descr="Text, letter&#10;&#10;Description automatically generated">
            <a:extLst>
              <a:ext uri="{FF2B5EF4-FFF2-40B4-BE49-F238E27FC236}">
                <a16:creationId xmlns:a16="http://schemas.microsoft.com/office/drawing/2014/main" id="{836D40D4-C774-06A5-A256-8E85180F21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5138" y="587046"/>
            <a:ext cx="11308057" cy="603953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7A2C2F4-944B-9597-9537-2A56DF77A956}"/>
              </a:ext>
            </a:extLst>
          </p:cNvPr>
          <p:cNvSpPr txBox="1"/>
          <p:nvPr/>
        </p:nvSpPr>
        <p:spPr>
          <a:xfrm>
            <a:off x="2891426" y="2072196"/>
            <a:ext cx="18324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GAPDH for MTIF3</a:t>
            </a:r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578A6F9E-24F9-A8BE-3C3C-A074BA0BFAB2}"/>
              </a:ext>
            </a:extLst>
          </p:cNvPr>
          <p:cNvCxnSpPr/>
          <p:nvPr/>
        </p:nvCxnSpPr>
        <p:spPr>
          <a:xfrm>
            <a:off x="4679807" y="3624518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TextBox 2">
            <a:extLst>
              <a:ext uri="{FF2B5EF4-FFF2-40B4-BE49-F238E27FC236}">
                <a16:creationId xmlns:a16="http://schemas.microsoft.com/office/drawing/2014/main" id="{B3EEDF15-A4B1-78AE-3BF8-4537DF6C5F71}"/>
              </a:ext>
            </a:extLst>
          </p:cNvPr>
          <p:cNvSpPr txBox="1"/>
          <p:nvPr/>
        </p:nvSpPr>
        <p:spPr>
          <a:xfrm>
            <a:off x="3894265" y="342138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37 kDa</a:t>
            </a:r>
          </a:p>
        </p:txBody>
      </p:sp>
    </p:spTree>
    <p:extLst>
      <p:ext uri="{BB962C8B-B14F-4D97-AF65-F5344CB8AC3E}">
        <p14:creationId xmlns:p14="http://schemas.microsoft.com/office/powerpoint/2010/main" val="18793782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&#10;&#10;Description automatically generated">
            <a:extLst>
              <a:ext uri="{FF2B5EF4-FFF2-40B4-BE49-F238E27FC236}">
                <a16:creationId xmlns:a16="http://schemas.microsoft.com/office/drawing/2014/main" id="{9A42B75C-2981-D561-BF7C-7B3C2AC640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7280" y="712232"/>
            <a:ext cx="8633945" cy="608300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ECA2775-5C75-9DFF-022E-9B7A04C70FB1}"/>
              </a:ext>
            </a:extLst>
          </p:cNvPr>
          <p:cNvSpPr txBox="1"/>
          <p:nvPr/>
        </p:nvSpPr>
        <p:spPr>
          <a:xfrm>
            <a:off x="2787967" y="1277302"/>
            <a:ext cx="5629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CC</a:t>
            </a:r>
            <a:endParaRPr lang="en-SE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C6AD6057-2B0F-5B18-287D-9DDF6A6E8E19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3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66552B5A-FE16-C117-AE52-317704E3239F}"/>
              </a:ext>
            </a:extLst>
          </p:cNvPr>
          <p:cNvCxnSpPr/>
          <p:nvPr/>
        </p:nvCxnSpPr>
        <p:spPr>
          <a:xfrm>
            <a:off x="3920003" y="1863666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AFF11870-D4A1-FC95-A4C5-685E45C61D6A}"/>
              </a:ext>
            </a:extLst>
          </p:cNvPr>
          <p:cNvSpPr txBox="1"/>
          <p:nvPr/>
        </p:nvSpPr>
        <p:spPr>
          <a:xfrm>
            <a:off x="3037586" y="1679000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250 kDa</a:t>
            </a:r>
          </a:p>
        </p:txBody>
      </p:sp>
    </p:spTree>
    <p:extLst>
      <p:ext uri="{BB962C8B-B14F-4D97-AF65-F5344CB8AC3E}">
        <p14:creationId xmlns:p14="http://schemas.microsoft.com/office/powerpoint/2010/main" val="28461425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black pen on a white background&#10;&#10;Description automatically generated with medium confidence">
            <a:extLst>
              <a:ext uri="{FF2B5EF4-FFF2-40B4-BE49-F238E27FC236}">
                <a16:creationId xmlns:a16="http://schemas.microsoft.com/office/drawing/2014/main" id="{FC566842-9600-7CDE-E789-656ED8E34C6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71443" y="613683"/>
            <a:ext cx="7772400" cy="54760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820DF02-0037-D7FF-FF2F-D18CFB14C3A6}"/>
              </a:ext>
            </a:extLst>
          </p:cNvPr>
          <p:cNvSpPr txBox="1"/>
          <p:nvPr/>
        </p:nvSpPr>
        <p:spPr>
          <a:xfrm>
            <a:off x="2918732" y="2261508"/>
            <a:ext cx="7712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ABP4</a:t>
            </a:r>
            <a:endParaRPr lang="en-SE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DB8B72C-3144-12AA-1A9B-673C45EE83C0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3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263D4ED8-F864-FE32-294B-9DFCDF998760}"/>
              </a:ext>
            </a:extLst>
          </p:cNvPr>
          <p:cNvCxnSpPr/>
          <p:nvPr/>
        </p:nvCxnSpPr>
        <p:spPr>
          <a:xfrm>
            <a:off x="3823137" y="2776828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0856EF59-278F-4571-20AC-C43D602930F3}"/>
              </a:ext>
            </a:extLst>
          </p:cNvPr>
          <p:cNvSpPr txBox="1"/>
          <p:nvPr/>
        </p:nvSpPr>
        <p:spPr>
          <a:xfrm>
            <a:off x="3037595" y="257369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15 kDa</a:t>
            </a:r>
          </a:p>
        </p:txBody>
      </p:sp>
    </p:spTree>
    <p:extLst>
      <p:ext uri="{BB962C8B-B14F-4D97-AF65-F5344CB8AC3E}">
        <p14:creationId xmlns:p14="http://schemas.microsoft.com/office/powerpoint/2010/main" val="1435523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text, white, document&#10;&#10;Description automatically generated">
            <a:extLst>
              <a:ext uri="{FF2B5EF4-FFF2-40B4-BE49-F238E27FC236}">
                <a16:creationId xmlns:a16="http://schemas.microsoft.com/office/drawing/2014/main" id="{E8460202-2189-1A95-A58E-C1600B19DFC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4745" y="285750"/>
            <a:ext cx="7772400" cy="54760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68A8CEF-B418-5B02-69CC-EC53512D41AB}"/>
              </a:ext>
            </a:extLst>
          </p:cNvPr>
          <p:cNvSpPr txBox="1"/>
          <p:nvPr/>
        </p:nvSpPr>
        <p:spPr>
          <a:xfrm>
            <a:off x="885825" y="342900"/>
            <a:ext cx="27519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altLang="zh-CN" dirty="0"/>
              <a:t>β</a:t>
            </a:r>
            <a:r>
              <a:rPr lang="sv-SE" altLang="zh-CN" dirty="0"/>
              <a:t>-</a:t>
            </a:r>
            <a:r>
              <a:rPr lang="en-US" altLang="zh-CN" dirty="0"/>
              <a:t>ACTIN</a:t>
            </a:r>
            <a:r>
              <a:rPr lang="zh-CN" altLang="en-US" dirty="0"/>
              <a:t> </a:t>
            </a:r>
            <a:r>
              <a:rPr lang="en-US" altLang="zh-CN" dirty="0"/>
              <a:t>for</a:t>
            </a:r>
            <a:r>
              <a:rPr lang="zh-CN" altLang="en-US" dirty="0"/>
              <a:t> </a:t>
            </a:r>
            <a:r>
              <a:rPr lang="en-US" altLang="zh-CN" dirty="0"/>
              <a:t>ACC and FABP4</a:t>
            </a:r>
            <a:endParaRPr lang="en-SE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B67013B-0DE7-CF60-6E34-C5543980CE16}"/>
              </a:ext>
            </a:extLst>
          </p:cNvPr>
          <p:cNvSpPr txBox="1"/>
          <p:nvPr/>
        </p:nvSpPr>
        <p:spPr>
          <a:xfrm>
            <a:off x="1586220" y="2709241"/>
            <a:ext cx="10426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zh-CN" dirty="0"/>
              <a:t>β</a:t>
            </a:r>
            <a:r>
              <a:rPr lang="sv-SE" altLang="zh-CN" dirty="0"/>
              <a:t>-</a:t>
            </a:r>
            <a:r>
              <a:rPr lang="en-US" altLang="zh-CN" dirty="0"/>
              <a:t>ACTIN</a:t>
            </a:r>
            <a:endParaRPr lang="en-SE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5A4534-CE54-E3CE-B923-C5E17DB54D8D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3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62A171CE-DDEA-3D16-AF59-670ABC188E85}"/>
              </a:ext>
            </a:extLst>
          </p:cNvPr>
          <p:cNvCxnSpPr/>
          <p:nvPr/>
        </p:nvCxnSpPr>
        <p:spPr>
          <a:xfrm>
            <a:off x="2585369" y="3447472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87428A6A-D529-59DF-7275-C6BC4C8099DE}"/>
              </a:ext>
            </a:extLst>
          </p:cNvPr>
          <p:cNvSpPr txBox="1"/>
          <p:nvPr/>
        </p:nvSpPr>
        <p:spPr>
          <a:xfrm>
            <a:off x="1799827" y="3244334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37 kDa</a:t>
            </a:r>
          </a:p>
        </p:txBody>
      </p:sp>
    </p:spTree>
    <p:extLst>
      <p:ext uri="{BB962C8B-B14F-4D97-AF65-F5344CB8AC3E}">
        <p14:creationId xmlns:p14="http://schemas.microsoft.com/office/powerpoint/2010/main" val="374167454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86082AFC-250F-B62D-6C36-AD8424E2D1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02699" y="569459"/>
            <a:ext cx="7772400" cy="54760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16CDE21-5E0F-1305-ACCA-86862D1A0334}"/>
              </a:ext>
            </a:extLst>
          </p:cNvPr>
          <p:cNvSpPr txBox="1"/>
          <p:nvPr/>
        </p:nvSpPr>
        <p:spPr>
          <a:xfrm>
            <a:off x="3902031" y="1919967"/>
            <a:ext cx="5163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AS</a:t>
            </a:r>
            <a:endParaRPr lang="en-SE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2B81982B-BBED-90BD-A5B5-483A94208649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3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DCD879B1-49FB-84FC-E6AD-5E8976161B59}"/>
              </a:ext>
            </a:extLst>
          </p:cNvPr>
          <p:cNvCxnSpPr/>
          <p:nvPr/>
        </p:nvCxnSpPr>
        <p:spPr>
          <a:xfrm>
            <a:off x="4531216" y="2679246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88ECC128-895E-2D9F-BA02-D5E351A20CF6}"/>
              </a:ext>
            </a:extLst>
          </p:cNvPr>
          <p:cNvSpPr txBox="1"/>
          <p:nvPr/>
        </p:nvSpPr>
        <p:spPr>
          <a:xfrm>
            <a:off x="3678999" y="2476108"/>
            <a:ext cx="9460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250 kDa</a:t>
            </a:r>
          </a:p>
        </p:txBody>
      </p:sp>
    </p:spTree>
    <p:extLst>
      <p:ext uri="{BB962C8B-B14F-4D97-AF65-F5344CB8AC3E}">
        <p14:creationId xmlns:p14="http://schemas.microsoft.com/office/powerpoint/2010/main" val="42208939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Graphical user interface, text&#10;&#10;Description automatically generated">
            <a:extLst>
              <a:ext uri="{FF2B5EF4-FFF2-40B4-BE49-F238E27FC236}">
                <a16:creationId xmlns:a16="http://schemas.microsoft.com/office/drawing/2014/main" id="{1BCD27C7-B3C2-4E8C-DD70-2D126036F3A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29044" y="690995"/>
            <a:ext cx="7772400" cy="547600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A7619A-2B43-AEE7-57DD-C036130D1EFB}"/>
              </a:ext>
            </a:extLst>
          </p:cNvPr>
          <p:cNvSpPr txBox="1"/>
          <p:nvPr/>
        </p:nvSpPr>
        <p:spPr>
          <a:xfrm>
            <a:off x="503282" y="587046"/>
            <a:ext cx="183986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dirty="0"/>
              <a:t>β</a:t>
            </a:r>
            <a:r>
              <a:rPr lang="sv-SE" altLang="zh-CN" dirty="0"/>
              <a:t>-</a:t>
            </a:r>
            <a:r>
              <a:rPr lang="en-US" altLang="zh-CN" dirty="0"/>
              <a:t>ACTIN</a:t>
            </a:r>
            <a:r>
              <a:rPr lang="zh-CN" altLang="en-US" dirty="0"/>
              <a:t> </a:t>
            </a:r>
            <a:r>
              <a:rPr lang="en-US" altLang="zh-CN" dirty="0"/>
              <a:t>for</a:t>
            </a:r>
            <a:r>
              <a:rPr lang="zh-CN" altLang="en-US" dirty="0"/>
              <a:t> </a:t>
            </a:r>
            <a:r>
              <a:rPr lang="en-US" altLang="zh-CN" dirty="0"/>
              <a:t>FAS</a:t>
            </a:r>
            <a:endParaRPr lang="en-SE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9D3291-A620-E78A-DD5C-1781F60EEC0C}"/>
              </a:ext>
            </a:extLst>
          </p:cNvPr>
          <p:cNvSpPr txBox="1"/>
          <p:nvPr/>
        </p:nvSpPr>
        <p:spPr>
          <a:xfrm>
            <a:off x="163286" y="217714"/>
            <a:ext cx="6799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Fig. 3</a:t>
            </a:r>
          </a:p>
        </p:txBody>
      </p:sp>
      <p:cxnSp>
        <p:nvCxnSpPr>
          <p:cNvPr id="3" name="Straight Connector 2">
            <a:extLst>
              <a:ext uri="{FF2B5EF4-FFF2-40B4-BE49-F238E27FC236}">
                <a16:creationId xmlns:a16="http://schemas.microsoft.com/office/drawing/2014/main" id="{8A895201-2FD4-FDF3-D48D-D1890A4F18DD}"/>
              </a:ext>
            </a:extLst>
          </p:cNvPr>
          <p:cNvCxnSpPr/>
          <p:nvPr/>
        </p:nvCxnSpPr>
        <p:spPr>
          <a:xfrm>
            <a:off x="2809404" y="1907378"/>
            <a:ext cx="111318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33A461C8-D758-8EF8-5CB3-0213621CEFE4}"/>
              </a:ext>
            </a:extLst>
          </p:cNvPr>
          <p:cNvSpPr txBox="1"/>
          <p:nvPr/>
        </p:nvSpPr>
        <p:spPr>
          <a:xfrm>
            <a:off x="2023862" y="1704240"/>
            <a:ext cx="829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SE" dirty="0"/>
              <a:t>37 kDa</a:t>
            </a:r>
          </a:p>
        </p:txBody>
      </p:sp>
    </p:spTree>
    <p:extLst>
      <p:ext uri="{BB962C8B-B14F-4D97-AF65-F5344CB8AC3E}">
        <p14:creationId xmlns:p14="http://schemas.microsoft.com/office/powerpoint/2010/main" val="33810377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57</Words>
  <Application>Microsoft Macintosh PowerPoint</Application>
  <PresentationFormat>Widescreen</PresentationFormat>
  <Paragraphs>2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等线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23-02-18T15:44:14Z</dcterms:created>
  <dcterms:modified xsi:type="dcterms:W3CDTF">2023-03-14T17:54:05Z</dcterms:modified>
</cp:coreProperties>
</file>